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280" y="-4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7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notesMaster" Target="notesMasters/notesMaster1.xml"/><Relationship Id="rId6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FN_manip%202012_tous_2T_en%20cours\Compil%20IFN_v10.0_Tstr_cin_T_IJ5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L10_manip%202012_tous_2T_newT_newIJ5\Compil%20IL10_v%2011.0_Tstr_cin_2T_T_IJ5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6545064118633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FN Témoins str (2)'!$AJ$1:$AK$1</c:f>
              <c:strCache>
                <c:ptCount val="1"/>
                <c:pt idx="0">
                  <c:v>IFN_Témoins I CEC Col / T.NORM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IFN Témoins str (2)'!$AG$4,'IFN Témoins str (2)'!$AG$8,'IFN Témoins str (2)'!$AG$11,'IFN Témoins str (2)'!$AG$14,'IFN Témoins str (2)'!$AG$17,'IFN Témoins str (2)'!$AG$20,'IFN Témoins str (2)'!$AG$24,'IFN Témoins str (2)'!$AG$29,'IFN Témoins str (2)'!$AG$33)</c:f>
                <c:numCache>
                  <c:formatCode>General</c:formatCode>
                  <c:ptCount val="9"/>
                  <c:pt idx="0">
                    <c:v>2.280658751309294</c:v>
                  </c:pt>
                  <c:pt idx="1">
                    <c:v>1.80054626819175</c:v>
                  </c:pt>
                  <c:pt idx="2">
                    <c:v>0.179621168367861</c:v>
                  </c:pt>
                  <c:pt idx="3">
                    <c:v>0.124625671456884</c:v>
                  </c:pt>
                  <c:pt idx="5">
                    <c:v>0.468719369048266</c:v>
                  </c:pt>
                  <c:pt idx="6">
                    <c:v>1.207444901305483</c:v>
                  </c:pt>
                  <c:pt idx="7">
                    <c:v>0.177675804032706</c:v>
                  </c:pt>
                  <c:pt idx="8">
                    <c:v>0.340598140439436</c:v>
                  </c:pt>
                </c:numCache>
              </c:numRef>
            </c:plus>
            <c:minus>
              <c:numRef>
                <c:f>('IFN Témoins str (2)'!$AG$4,'IFN Témoins str (2)'!$AG$8,'IFN Témoins str (2)'!$AG$11,'IFN Témoins str (2)'!$AG$14,'IFN Témoins str (2)'!$AG$17,'IFN Témoins str (2)'!$AG$20,'IFN Témoins str (2)'!$AG$24,'IFN Témoins str (2)'!$AG$29,'IFN Témoins str (2)'!$AG$33)</c:f>
                <c:numCache>
                  <c:formatCode>General</c:formatCode>
                  <c:ptCount val="9"/>
                  <c:pt idx="0">
                    <c:v>2.280658751309294</c:v>
                  </c:pt>
                  <c:pt idx="1">
                    <c:v>1.80054626819175</c:v>
                  </c:pt>
                  <c:pt idx="2">
                    <c:v>0.179621168367861</c:v>
                  </c:pt>
                  <c:pt idx="3">
                    <c:v>0.124625671456884</c:v>
                  </c:pt>
                  <c:pt idx="5">
                    <c:v>0.468719369048266</c:v>
                  </c:pt>
                  <c:pt idx="6">
                    <c:v>1.207444901305483</c:v>
                  </c:pt>
                  <c:pt idx="7">
                    <c:v>0.177675804032706</c:v>
                  </c:pt>
                  <c:pt idx="8">
                    <c:v>0.340598140439436</c:v>
                  </c:pt>
                </c:numCache>
              </c:numRef>
            </c:minus>
          </c:errBars>
          <c:cat>
            <c:strRef>
              <c:f>('IFN Témoins str (2)'!$Z$4,'IFN Témoins str (2)'!$Z$8,'IFN Témoins str (2)'!$Z$11,'IFN Témoins str (2)'!$Z$14,'IFN Témoins str (2)'!$Z$17,'IFN Témoins str (2)'!$Z$20,'IFN Témoins str (2)'!$Z$24,'IFN Témoins str (2)'!$Z$29,'IFN Témoins str (2)'!$Z$33)</c:f>
              <c:strCache>
                <c:ptCount val="9"/>
                <c:pt idx="0">
                  <c:v>T Norm_I_-_T1_moy</c:v>
                </c:pt>
                <c:pt idx="1">
                  <c:v>T Strepto_I_-_T2_moy</c:v>
                </c:pt>
                <c:pt idx="2">
                  <c:v>T Sb Strepto_I_-_T3_moy</c:v>
                </c:pt>
                <c:pt idx="3">
                  <c:v>T Norm_CEC_-_T1_moy</c:v>
                </c:pt>
                <c:pt idx="4">
                  <c:v>T Strepto_CEC_-_T2_moy</c:v>
                </c:pt>
                <c:pt idx="5">
                  <c:v>T Sb Strepto_CEC_-_T3_moy</c:v>
                </c:pt>
                <c:pt idx="6">
                  <c:v>T Norm_Col._-_T1_moy</c:v>
                </c:pt>
                <c:pt idx="7">
                  <c:v>T Strepto_Col_-_T2_moy</c:v>
                </c:pt>
                <c:pt idx="8">
                  <c:v>T Sb Strepto_Col_-_T3_moy</c:v>
                </c:pt>
              </c:strCache>
            </c:strRef>
          </c:cat>
          <c:val>
            <c:numRef>
              <c:f>('IFN Témoins str (2)'!$AF$4,'IFN Témoins str (2)'!$AF$8,'IFN Témoins str (2)'!$AF$11,'IFN Témoins str (2)'!$AF$14,'IFN Témoins str (2)'!$AF$17,'IFN Témoins str (2)'!$AF$20,'IFN Témoins str (2)'!$AF$24,'IFN Témoins str (2)'!$AF$29,'IFN Témoins str (2)'!$AF$33)</c:f>
              <c:numCache>
                <c:formatCode>General</c:formatCode>
                <c:ptCount val="9"/>
                <c:pt idx="0">
                  <c:v>1.0</c:v>
                </c:pt>
                <c:pt idx="1">
                  <c:v>8.6038329563865</c:v>
                </c:pt>
                <c:pt idx="2">
                  <c:v>2.649273396888606</c:v>
                </c:pt>
                <c:pt idx="3">
                  <c:v>1.0</c:v>
                </c:pt>
                <c:pt idx="4">
                  <c:v>1.817000622939094</c:v>
                </c:pt>
                <c:pt idx="5">
                  <c:v>1.616430511633212</c:v>
                </c:pt>
                <c:pt idx="6">
                  <c:v>1.0</c:v>
                </c:pt>
                <c:pt idx="7">
                  <c:v>0.840907903174974</c:v>
                </c:pt>
                <c:pt idx="8">
                  <c:v>0.6533829137348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07159272"/>
        <c:axId val="423104808"/>
      </c:barChart>
      <c:catAx>
        <c:axId val="5071592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423104808"/>
        <c:crossesAt val="0.1"/>
        <c:auto val="1"/>
        <c:lblAlgn val="ctr"/>
        <c:lblOffset val="100"/>
        <c:noMultiLvlLbl val="0"/>
      </c:catAx>
      <c:valAx>
        <c:axId val="423104808"/>
        <c:scaling>
          <c:logBase val="10.0"/>
          <c:orientation val="minMax"/>
          <c:min val="0.1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507159272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5474330560948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10 témoin (2)'!$AU$1:$AV$1</c:f>
              <c:strCache>
                <c:ptCount val="1"/>
                <c:pt idx="0">
                  <c:v>IL10_Témoins I CEC Col / T.NORM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IL10 témoin (2)'!$AR$4,'IL10 témoin (2)'!$AR$8,'IL10 témoin (2)'!$AS$11,'IL10 témoin (2)'!$AR$15,'IL10 témoin (2)'!$AR$18,'IL10 témoin (2)'!$AR$21,'IL10 témoin (2)'!$AR$26,'IL10 témoin (2)'!$AR$31,'IL10 témoin (2)'!$AR$35)</c:f>
                <c:numCache>
                  <c:formatCode>General</c:formatCode>
                  <c:ptCount val="9"/>
                  <c:pt idx="0">
                    <c:v>3.784244892361984</c:v>
                  </c:pt>
                  <c:pt idx="1">
                    <c:v>0.227618472026338</c:v>
                  </c:pt>
                  <c:pt idx="2">
                    <c:v>4.761125702200128</c:v>
                  </c:pt>
                  <c:pt idx="3">
                    <c:v>0.392884250421766</c:v>
                  </c:pt>
                  <c:pt idx="4">
                    <c:v>1.0</c:v>
                  </c:pt>
                  <c:pt idx="5">
                    <c:v>0.24439030429111</c:v>
                  </c:pt>
                  <c:pt idx="6">
                    <c:v>0.662905901536516</c:v>
                  </c:pt>
                  <c:pt idx="7">
                    <c:v>0.256875174494818</c:v>
                  </c:pt>
                  <c:pt idx="8">
                    <c:v>0.112537946462093</c:v>
                  </c:pt>
                </c:numCache>
              </c:numRef>
            </c:plus>
            <c:minus>
              <c:numRef>
                <c:f>('IL10 témoin (2)'!$AR$4,'IL10 témoin (2)'!$AR$8,'IL10 témoin (2)'!$AS$11,'IL10 témoin (2)'!$AR$15,'IL10 témoin (2)'!$AR$18,'IL10 témoin (2)'!$AR$21,'IL10 témoin (2)'!$AR$26,'IL10 témoin (2)'!$AR$31,'IL10 témoin (2)'!$AR$35)</c:f>
                <c:numCache>
                  <c:formatCode>General</c:formatCode>
                  <c:ptCount val="9"/>
                  <c:pt idx="0">
                    <c:v>3.784244892361984</c:v>
                  </c:pt>
                  <c:pt idx="1">
                    <c:v>0.227618472026338</c:v>
                  </c:pt>
                  <c:pt idx="2">
                    <c:v>4.761125702200128</c:v>
                  </c:pt>
                  <c:pt idx="3">
                    <c:v>0.392884250421766</c:v>
                  </c:pt>
                  <c:pt idx="4">
                    <c:v>1.0</c:v>
                  </c:pt>
                  <c:pt idx="5">
                    <c:v>0.24439030429111</c:v>
                  </c:pt>
                  <c:pt idx="6">
                    <c:v>0.662905901536516</c:v>
                  </c:pt>
                  <c:pt idx="7">
                    <c:v>0.256875174494818</c:v>
                  </c:pt>
                  <c:pt idx="8">
                    <c:v>0.112537946462093</c:v>
                  </c:pt>
                </c:numCache>
              </c:numRef>
            </c:minus>
          </c:errBars>
          <c:cat>
            <c:strRef>
              <c:f>('IL10 témoin (2)'!$AM$4,'IL10 témoin (2)'!$AM$8,'IL10 témoin (2)'!$AM$11,'IL10 témoin (2)'!$AM$15,'IL10 témoin (2)'!$AM$18,'IL10 témoin (2)'!$AM$21,'IL10 témoin (2)'!$AM$26,'IL10 témoin (2)'!$AM$31,'IL10 témoin (2)'!$AM$35)</c:f>
              <c:strCache>
                <c:ptCount val="9"/>
                <c:pt idx="0">
                  <c:v>T Norm_I_-_T1_moy</c:v>
                </c:pt>
                <c:pt idx="1">
                  <c:v>T Strepto_I_-_T2_moy</c:v>
                </c:pt>
                <c:pt idx="2">
                  <c:v>T Sb Strepto_I_-_T3_moy</c:v>
                </c:pt>
                <c:pt idx="3">
                  <c:v>T Norm_CEC_-_T1_moy</c:v>
                </c:pt>
                <c:pt idx="4">
                  <c:v>T Strepto_CEC_-_T2_moy</c:v>
                </c:pt>
                <c:pt idx="5">
                  <c:v>T Sb Strepto_CEC_-_T3_moy</c:v>
                </c:pt>
                <c:pt idx="6">
                  <c:v>T Norm_Col._-_T1_moy</c:v>
                </c:pt>
                <c:pt idx="7">
                  <c:v>T Strepto_Col_-_T2_moy</c:v>
                </c:pt>
                <c:pt idx="8">
                  <c:v>T Sb Strepto_Col_-_T3_moy</c:v>
                </c:pt>
              </c:strCache>
            </c:strRef>
          </c:cat>
          <c:val>
            <c:numRef>
              <c:f>('IL10 témoin (2)'!$AQ$4,'IL10 témoin (2)'!$AQ$8,'IL10 témoin (2)'!$AQ$11,'IL10 témoin (2)'!$AQ$15,'IL10 témoin (2)'!$AQ$18,'IL10 témoin (2)'!$AQ$21,'IL10 témoin (2)'!$AQ$26,'IL10 témoin (2)'!$AQ$31,'IL10 témoin (2)'!$AQ$35)</c:f>
              <c:numCache>
                <c:formatCode>General</c:formatCode>
                <c:ptCount val="9"/>
                <c:pt idx="0">
                  <c:v>1.0</c:v>
                </c:pt>
                <c:pt idx="1">
                  <c:v>0.765344899229321</c:v>
                </c:pt>
                <c:pt idx="2">
                  <c:v>9.51445014900831</c:v>
                </c:pt>
                <c:pt idx="3">
                  <c:v>1.0</c:v>
                </c:pt>
                <c:pt idx="4">
                  <c:v>1.343659407331773</c:v>
                </c:pt>
                <c:pt idx="5">
                  <c:v>0.525912193897074</c:v>
                </c:pt>
                <c:pt idx="6">
                  <c:v>1.0</c:v>
                </c:pt>
                <c:pt idx="7">
                  <c:v>0.924972857421226</c:v>
                </c:pt>
                <c:pt idx="8">
                  <c:v>0.3828211044172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96471416"/>
        <c:axId val="14398200"/>
      </c:barChart>
      <c:catAx>
        <c:axId val="3964714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14398200"/>
        <c:crossesAt val="0.1"/>
        <c:auto val="1"/>
        <c:lblAlgn val="ctr"/>
        <c:lblOffset val="100"/>
        <c:noMultiLvlLbl val="0"/>
      </c:catAx>
      <c:valAx>
        <c:axId val="14398200"/>
        <c:scaling>
          <c:logBase val="10.0"/>
          <c:orientation val="minMax"/>
          <c:min val="0.1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396471416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301567-909A-405F-9522-818C3E7354BB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1A1FDC-A212-4580-B1C5-78063E3F9D9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808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34D79-47CF-4EE9-A820-5810DC76BB4E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549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CE24D-4A29-4DF8-823C-AF5B18068F8C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9325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3D6BA-EB6A-405F-9F86-A83365C6FA23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643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AABE6-AF8D-46E3-9ED6-036EF8EAEDCA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7608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4F1A6-4D11-4C1B-9F1D-47A5D7983FAC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62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A8DF8-9E4E-40FB-8A77-AE6A3539DC60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842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F5B0B-5A25-4BE6-9A66-5D37CCB4F51F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9320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AE76E-F771-4218-A394-3E80841FC9A7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9912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4FFC4-5F5F-4DC5-AB9D-9892AD6C48C5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9206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2871-7EDD-4160-AA54-FC1DB2E092F6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145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95259-8032-4E02-8B6D-ED5723CAF6E8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8968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DDF90-6E79-44FA-BA73-B4087F9C1CAD}" type="datetime9">
              <a:rPr lang="fr-FR" smtClean="0"/>
              <a:t>01/07/14 4:55 pm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fr-FR" smtClean="0"/>
              <a:t>Article BLI_Témoins_toutes amorces_newT_Stat.pptx</a:t>
            </a: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76148-4C15-41DE-9674-29C1695FD9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672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49F3A-739E-344B-875A-867C3C9B77F2}" type="slidenum">
              <a:rPr lang="fr-FR" smtClean="0"/>
              <a:pPr/>
              <a:t>1</a:t>
            </a:fld>
            <a:endParaRPr lang="fr-FR"/>
          </a:p>
        </p:txBody>
      </p:sp>
      <p:graphicFrame>
        <p:nvGraphicFramePr>
          <p:cNvPr id="25" name="Graphique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9665732"/>
              </p:ext>
            </p:extLst>
          </p:nvPr>
        </p:nvGraphicFramePr>
        <p:xfrm>
          <a:off x="552291" y="1020114"/>
          <a:ext cx="2592288" cy="17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5" name="ZoneTexte 114"/>
          <p:cNvSpPr txBox="1"/>
          <p:nvPr/>
        </p:nvSpPr>
        <p:spPr>
          <a:xfrm>
            <a:off x="908059" y="2966755"/>
            <a:ext cx="2274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IL-</a:t>
            </a:r>
            <a:r>
              <a:rPr lang="fr-FR" sz="1000" b="1" dirty="0">
                <a:latin typeface="Arial"/>
                <a:cs typeface="Arial"/>
              </a:rPr>
              <a:t>10mRNA </a:t>
            </a:r>
            <a:r>
              <a:rPr lang="fr-FR" sz="1000" b="1" dirty="0" err="1">
                <a:latin typeface="Arial"/>
                <a:cs typeface="Arial"/>
              </a:rPr>
              <a:t>fold</a:t>
            </a:r>
            <a:r>
              <a:rPr lang="fr-FR" sz="1000" b="1" dirty="0">
                <a:latin typeface="Arial"/>
                <a:cs typeface="Arial"/>
              </a:rPr>
              <a:t> change vs control </a:t>
            </a:r>
          </a:p>
          <a:p>
            <a:endParaRPr lang="fr-FR" sz="1000" b="1" dirty="0">
              <a:latin typeface="Symbol" charset="2"/>
              <a:cs typeface="Symbol" charset="2"/>
            </a:endParaRPr>
          </a:p>
        </p:txBody>
      </p:sp>
      <p:grpSp>
        <p:nvGrpSpPr>
          <p:cNvPr id="116" name="Grouper 115"/>
          <p:cNvGrpSpPr/>
          <p:nvPr/>
        </p:nvGrpSpPr>
        <p:grpSpPr>
          <a:xfrm>
            <a:off x="331995" y="2265455"/>
            <a:ext cx="2808312" cy="659489"/>
            <a:chOff x="107504" y="1980332"/>
            <a:chExt cx="2808312" cy="659489"/>
          </a:xfrm>
        </p:grpSpPr>
        <p:sp>
          <p:nvSpPr>
            <p:cNvPr id="117" name="ZoneTexte 116"/>
            <p:cNvSpPr txBox="1"/>
            <p:nvPr/>
          </p:nvSpPr>
          <p:spPr>
            <a:xfrm>
              <a:off x="690995" y="2390691"/>
              <a:ext cx="711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Intestine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1439441" y="2393600"/>
              <a:ext cx="61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 smtClean="0">
                  <a:latin typeface="Arial"/>
                  <a:cs typeface="Arial"/>
                </a:rPr>
                <a:t>Cecum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2278011" y="2393600"/>
              <a:ext cx="5479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Colon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131564" y="2016398"/>
              <a:ext cx="3628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 smtClean="0">
                  <a:latin typeface="Arial"/>
                  <a:cs typeface="Arial"/>
                </a:rPr>
                <a:t>Str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107504" y="2246675"/>
              <a:ext cx="5249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i="1" dirty="0" err="1" smtClean="0">
                  <a:latin typeface="Arial"/>
                  <a:cs typeface="Arial"/>
                </a:rPr>
                <a:t>S.b</a:t>
              </a:r>
              <a:r>
                <a:rPr lang="fr-FR" sz="1000" b="1" dirty="0" smtClean="0">
                  <a:latin typeface="Arial"/>
                  <a:cs typeface="Arial"/>
                </a:rPr>
                <a:t>-B</a:t>
              </a:r>
              <a:endParaRPr lang="fr-FR" sz="1000" b="1" dirty="0">
                <a:latin typeface="Arial"/>
                <a:cs typeface="Arial"/>
              </a:endParaRPr>
            </a:p>
          </p:txBody>
        </p:sp>
        <p:grpSp>
          <p:nvGrpSpPr>
            <p:cNvPr id="122" name="Grouper 121"/>
            <p:cNvGrpSpPr/>
            <p:nvPr/>
          </p:nvGrpSpPr>
          <p:grpSpPr>
            <a:xfrm>
              <a:off x="699509" y="1988840"/>
              <a:ext cx="730971" cy="451098"/>
              <a:chOff x="699509" y="2016398"/>
              <a:chExt cx="730971" cy="451098"/>
            </a:xfrm>
          </p:grpSpPr>
          <p:sp>
            <p:nvSpPr>
              <p:cNvPr id="139" name="ZoneTexte 138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41" name="ZoneTexte 140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42" name="ZoneTexte 141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43" name="ZoneTexte 142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45" name="Connecteur droit 144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er 122"/>
            <p:cNvGrpSpPr/>
            <p:nvPr/>
          </p:nvGrpSpPr>
          <p:grpSpPr>
            <a:xfrm>
              <a:off x="1464765" y="1980332"/>
              <a:ext cx="730971" cy="451098"/>
              <a:chOff x="699509" y="2016398"/>
              <a:chExt cx="730971" cy="451098"/>
            </a:xfrm>
          </p:grpSpPr>
          <p:sp>
            <p:nvSpPr>
              <p:cNvPr id="132" name="ZoneTexte 131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33" name="ZoneTexte 132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34" name="ZoneTexte 133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35" name="ZoneTexte 134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37" name="ZoneTexte 136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38" name="Connecteur droit 137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4" name="Grouper 123"/>
            <p:cNvGrpSpPr/>
            <p:nvPr/>
          </p:nvGrpSpPr>
          <p:grpSpPr>
            <a:xfrm>
              <a:off x="2184845" y="1984648"/>
              <a:ext cx="730971" cy="451098"/>
              <a:chOff x="699509" y="2016398"/>
              <a:chExt cx="730971" cy="451098"/>
            </a:xfrm>
          </p:grpSpPr>
          <p:sp>
            <p:nvSpPr>
              <p:cNvPr id="125" name="ZoneTexte 124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28" name="ZoneTexte 127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29" name="ZoneTexte 128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31" name="Connecteur droit 130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6" name="ZoneTexte 145"/>
          <p:cNvSpPr txBox="1"/>
          <p:nvPr/>
        </p:nvSpPr>
        <p:spPr>
          <a:xfrm>
            <a:off x="929078" y="950531"/>
            <a:ext cx="23095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IFN-</a:t>
            </a:r>
            <a:r>
              <a:rPr lang="fr-FR" sz="1000" b="1" dirty="0" smtClean="0">
                <a:latin typeface="Symbol" charset="2"/>
                <a:cs typeface="Symbol" charset="2"/>
              </a:rPr>
              <a:t>g </a:t>
            </a:r>
            <a:r>
              <a:rPr lang="fr-FR" sz="1000" b="1" dirty="0" err="1">
                <a:latin typeface="Arial"/>
                <a:cs typeface="Arial"/>
              </a:rPr>
              <a:t>mRNA</a:t>
            </a:r>
            <a:r>
              <a:rPr lang="fr-FR" sz="1000" b="1" dirty="0">
                <a:latin typeface="Arial"/>
                <a:cs typeface="Arial"/>
              </a:rPr>
              <a:t> </a:t>
            </a:r>
            <a:r>
              <a:rPr lang="fr-FR" sz="1000" b="1" dirty="0" err="1">
                <a:latin typeface="Arial"/>
                <a:cs typeface="Arial"/>
              </a:rPr>
              <a:t>fold</a:t>
            </a:r>
            <a:r>
              <a:rPr lang="fr-FR" sz="1000" b="1" dirty="0">
                <a:latin typeface="Arial"/>
                <a:cs typeface="Arial"/>
              </a:rPr>
              <a:t> change vs control </a:t>
            </a:r>
          </a:p>
          <a:p>
            <a:r>
              <a:rPr lang="fr-FR" sz="1000" b="1" dirty="0" smtClean="0">
                <a:latin typeface="Symbol" charset="2"/>
                <a:cs typeface="Symbol" charset="2"/>
              </a:rPr>
              <a:t> </a:t>
            </a:r>
            <a:endParaRPr lang="fr-FR" sz="1000" b="1" dirty="0">
              <a:latin typeface="Symbol" charset="2"/>
              <a:cs typeface="Symbol" charset="2"/>
            </a:endParaRPr>
          </a:p>
        </p:txBody>
      </p:sp>
      <p:graphicFrame>
        <p:nvGraphicFramePr>
          <p:cNvPr id="147" name="Graphique 1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6368339"/>
              </p:ext>
            </p:extLst>
          </p:nvPr>
        </p:nvGraphicFramePr>
        <p:xfrm>
          <a:off x="548019" y="3068960"/>
          <a:ext cx="259228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48" name="Grouper 147"/>
          <p:cNvGrpSpPr/>
          <p:nvPr/>
        </p:nvGrpSpPr>
        <p:grpSpPr>
          <a:xfrm>
            <a:off x="323528" y="4298613"/>
            <a:ext cx="2808312" cy="659489"/>
            <a:chOff x="107504" y="1980332"/>
            <a:chExt cx="2808312" cy="659489"/>
          </a:xfrm>
        </p:grpSpPr>
        <p:sp>
          <p:nvSpPr>
            <p:cNvPr id="149" name="ZoneTexte 148"/>
            <p:cNvSpPr txBox="1"/>
            <p:nvPr/>
          </p:nvSpPr>
          <p:spPr>
            <a:xfrm>
              <a:off x="690995" y="2390691"/>
              <a:ext cx="711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Intestine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50" name="ZoneTexte 149"/>
            <p:cNvSpPr txBox="1"/>
            <p:nvPr/>
          </p:nvSpPr>
          <p:spPr>
            <a:xfrm>
              <a:off x="1439441" y="2393600"/>
              <a:ext cx="61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 smtClean="0">
                  <a:latin typeface="Arial"/>
                  <a:cs typeface="Arial"/>
                </a:rPr>
                <a:t>Cecum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51" name="ZoneTexte 150"/>
            <p:cNvSpPr txBox="1"/>
            <p:nvPr/>
          </p:nvSpPr>
          <p:spPr>
            <a:xfrm>
              <a:off x="2278011" y="2393600"/>
              <a:ext cx="5479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Colon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131564" y="2016398"/>
              <a:ext cx="3628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 smtClean="0">
                  <a:latin typeface="Arial"/>
                  <a:cs typeface="Arial"/>
                </a:rPr>
                <a:t>Str</a:t>
              </a:r>
              <a:endParaRPr lang="fr-FR" sz="1000" b="1" dirty="0">
                <a:latin typeface="Arial"/>
                <a:cs typeface="Arial"/>
              </a:endParaRP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107504" y="2246675"/>
              <a:ext cx="5249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i="1" dirty="0" err="1" smtClean="0">
                  <a:latin typeface="Arial"/>
                  <a:cs typeface="Arial"/>
                </a:rPr>
                <a:t>S.b</a:t>
              </a:r>
              <a:r>
                <a:rPr lang="fr-FR" sz="1000" b="1" dirty="0" smtClean="0">
                  <a:latin typeface="Arial"/>
                  <a:cs typeface="Arial"/>
                </a:rPr>
                <a:t>-B</a:t>
              </a:r>
              <a:endParaRPr lang="fr-FR" sz="1000" b="1" dirty="0">
                <a:latin typeface="Arial"/>
                <a:cs typeface="Arial"/>
              </a:endParaRPr>
            </a:p>
          </p:txBody>
        </p:sp>
        <p:grpSp>
          <p:nvGrpSpPr>
            <p:cNvPr id="154" name="Grouper 153"/>
            <p:cNvGrpSpPr/>
            <p:nvPr/>
          </p:nvGrpSpPr>
          <p:grpSpPr>
            <a:xfrm>
              <a:off x="699509" y="1988840"/>
              <a:ext cx="730971" cy="451098"/>
              <a:chOff x="699509" y="2016398"/>
              <a:chExt cx="730971" cy="451098"/>
            </a:xfrm>
          </p:grpSpPr>
          <p:sp>
            <p:nvSpPr>
              <p:cNvPr id="171" name="ZoneTexte 170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73" name="ZoneTexte 172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74" name="ZoneTexte 173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75" name="ZoneTexte 174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76" name="ZoneTexte 175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77" name="Connecteur droit 176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er 154"/>
            <p:cNvGrpSpPr/>
            <p:nvPr/>
          </p:nvGrpSpPr>
          <p:grpSpPr>
            <a:xfrm>
              <a:off x="1464765" y="1980332"/>
              <a:ext cx="730971" cy="451098"/>
              <a:chOff x="699509" y="2016398"/>
              <a:chExt cx="730971" cy="451098"/>
            </a:xfrm>
          </p:grpSpPr>
          <p:sp>
            <p:nvSpPr>
              <p:cNvPr id="164" name="ZoneTexte 163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66" name="ZoneTexte 165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67" name="ZoneTexte 166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70" name="Connecteur droit 169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6" name="Grouper 155"/>
            <p:cNvGrpSpPr/>
            <p:nvPr/>
          </p:nvGrpSpPr>
          <p:grpSpPr>
            <a:xfrm>
              <a:off x="2184845" y="1984648"/>
              <a:ext cx="730971" cy="451098"/>
              <a:chOff x="699509" y="2016398"/>
              <a:chExt cx="730971" cy="451098"/>
            </a:xfrm>
          </p:grpSpPr>
          <p:sp>
            <p:nvSpPr>
              <p:cNvPr id="157" name="ZoneTexte 156"/>
              <p:cNvSpPr txBox="1"/>
              <p:nvPr/>
            </p:nvSpPr>
            <p:spPr>
              <a:xfrm>
                <a:off x="699509" y="201639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58" name="ZoneTexte 157"/>
              <p:cNvSpPr txBox="1"/>
              <p:nvPr/>
            </p:nvSpPr>
            <p:spPr>
              <a:xfrm>
                <a:off x="1165483" y="2221275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59" name="ZoneTexte 158"/>
              <p:cNvSpPr txBox="1"/>
              <p:nvPr/>
            </p:nvSpPr>
            <p:spPr>
              <a:xfrm>
                <a:off x="1160336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60" name="ZoneTexte 159"/>
              <p:cNvSpPr txBox="1"/>
              <p:nvPr/>
            </p:nvSpPr>
            <p:spPr>
              <a:xfrm>
                <a:off x="710856" y="2200548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sp>
            <p:nvSpPr>
              <p:cNvPr id="161" name="ZoneTexte 160"/>
              <p:cNvSpPr txBox="1"/>
              <p:nvPr/>
            </p:nvSpPr>
            <p:spPr>
              <a:xfrm>
                <a:off x="918848" y="2043686"/>
                <a:ext cx="2649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>
                    <a:latin typeface="Arial"/>
                    <a:cs typeface="Arial"/>
                  </a:rPr>
                  <a:t>+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62" name="ZoneTexte 161"/>
              <p:cNvSpPr txBox="1"/>
              <p:nvPr/>
            </p:nvSpPr>
            <p:spPr>
              <a:xfrm>
                <a:off x="946121" y="2207143"/>
                <a:ext cx="2273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>
                    <a:latin typeface="Arial"/>
                    <a:cs typeface="Arial"/>
                  </a:rPr>
                  <a:t>-</a:t>
                </a:r>
              </a:p>
            </p:txBody>
          </p:sp>
          <p:cxnSp>
            <p:nvCxnSpPr>
              <p:cNvPr id="163" name="Connecteur droit 162"/>
              <p:cNvCxnSpPr/>
              <p:nvPr/>
            </p:nvCxnSpPr>
            <p:spPr>
              <a:xfrm>
                <a:off x="725696" y="2438776"/>
                <a:ext cx="6545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10" name="ZoneTexte 209"/>
          <p:cNvSpPr txBox="1"/>
          <p:nvPr/>
        </p:nvSpPr>
        <p:spPr>
          <a:xfrm>
            <a:off x="179512" y="44624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>
                <a:latin typeface="Arial"/>
                <a:cs typeface="Arial"/>
              </a:rPr>
              <a:t>Figure S3</a:t>
            </a:r>
            <a:endParaRPr lang="fr-FR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059750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73</Words>
  <Application>Microsoft Macintosh PowerPoint</Application>
  <PresentationFormat>Présentation à l'écra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89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dolphe</dc:creator>
  <cp:lastModifiedBy>Dorota Czerucka</cp:lastModifiedBy>
  <cp:revision>33</cp:revision>
  <dcterms:created xsi:type="dcterms:W3CDTF">2013-04-19T13:08:34Z</dcterms:created>
  <dcterms:modified xsi:type="dcterms:W3CDTF">2014-07-01T14:55:14Z</dcterms:modified>
</cp:coreProperties>
</file>